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8" d="100"/>
          <a:sy n="68" d="100"/>
        </p:scale>
        <p:origin x="-3352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204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701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4877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92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28017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471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528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318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3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227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197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2C1CE-311C-C145-82B9-1EA8A475901D}" type="datetimeFigureOut">
              <a:rPr lang="en-US" smtClean="0"/>
              <a:t>6/1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A4CE3-F6AB-6748-A42F-B6D642B977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21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523102"/>
              </p:ext>
            </p:extLst>
          </p:nvPr>
        </p:nvGraphicFramePr>
        <p:xfrm>
          <a:off x="82660" y="2072746"/>
          <a:ext cx="6712679" cy="2865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8032"/>
                <a:gridCol w="1458772"/>
                <a:gridCol w="4345875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Target Site</a:t>
                      </a:r>
                      <a:r>
                        <a:rPr lang="en-US" baseline="0" dirty="0" smtClean="0"/>
                        <a:t> #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Clone</a:t>
                      </a:r>
                      <a:r>
                        <a:rPr lang="en-US" baseline="0" dirty="0" smtClean="0"/>
                        <a:t> ID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Primer</a:t>
                      </a:r>
                      <a:r>
                        <a:rPr lang="en-US" baseline="0" dirty="0" smtClean="0"/>
                        <a:t> </a:t>
                      </a:r>
                      <a:r>
                        <a:rPr lang="en-US" dirty="0" smtClean="0"/>
                        <a:t>Sequence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#1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Forward</a:t>
                      </a:r>
                      <a:r>
                        <a:rPr lang="en-US" baseline="0" dirty="0" smtClean="0"/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 smtClean="0"/>
                        <a:t>5’-CAC CGA GAG GAT CTA CCT ACT GTT G-3’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Reverse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 smtClean="0"/>
                        <a:t>5’-AAA CCA ACA</a:t>
                      </a:r>
                      <a:r>
                        <a:rPr lang="en-US" baseline="0" dirty="0" smtClean="0"/>
                        <a:t> GTA GGT AGA TCC TCT C-3’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#3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Forward</a:t>
                      </a:r>
                      <a:r>
                        <a:rPr lang="en-US" baseline="0" dirty="0" smtClean="0"/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 smtClean="0"/>
                        <a:t>5’-</a:t>
                      </a:r>
                      <a:r>
                        <a:rPr lang="en-US" baseline="0" dirty="0" smtClean="0"/>
                        <a:t> CAC CGG GGA ATC CTC CTG CAT CCG-3’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Reverse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 smtClean="0"/>
                        <a:t>5’-AAA CCG GAT GCA GGA</a:t>
                      </a:r>
                      <a:r>
                        <a:rPr lang="en-US" baseline="0" dirty="0" smtClean="0"/>
                        <a:t> GGA TTC CCC-3’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rowSpan="2"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#4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Forward</a:t>
                      </a:r>
                      <a:r>
                        <a:rPr lang="en-US" baseline="0" dirty="0" smtClean="0"/>
                        <a:t> 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 smtClean="0"/>
                        <a:t>5’-CAC</a:t>
                      </a:r>
                      <a:r>
                        <a:rPr lang="en-US" baseline="0" dirty="0" smtClean="0"/>
                        <a:t> CGT  CTG GGT GAA TCC TCT TCA C-3’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 vMerge="1">
                  <a:txBody>
                    <a:bodyPr/>
                    <a:lstStyle/>
                    <a:p>
                      <a:pPr algn="ctr"/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Reverse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dirty="0" smtClean="0"/>
                        <a:t>5’-AAA</a:t>
                      </a:r>
                      <a:r>
                        <a:rPr lang="en-US" baseline="0" dirty="0" smtClean="0"/>
                        <a:t> CGT GAA GAG GAT TCA CCC AGA C-3’</a:t>
                      </a:r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81871" y="8583369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2 Table 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0893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Frost</dc:creator>
  <cp:lastModifiedBy>Susan Frost</cp:lastModifiedBy>
  <cp:revision>1</cp:revision>
  <dcterms:created xsi:type="dcterms:W3CDTF">2018-06-13T18:17:11Z</dcterms:created>
  <dcterms:modified xsi:type="dcterms:W3CDTF">2018-06-13T18:17:43Z</dcterms:modified>
</cp:coreProperties>
</file>